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61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FA263-3CDD-4706-8345-28DF31156A44}" type="datetimeFigureOut">
              <a:rPr lang="en-US" smtClean="0"/>
              <a:t>9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745E3A-DD22-4C4F-BE9D-3827AC35C70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/>
          <p:cNvGrpSpPr/>
          <p:nvPr/>
        </p:nvGrpSpPr>
        <p:grpSpPr>
          <a:xfrm>
            <a:off x="538165" y="451338"/>
            <a:ext cx="8433933" cy="5945813"/>
            <a:chOff x="538165" y="451338"/>
            <a:chExt cx="8433933" cy="5945813"/>
          </a:xfrm>
        </p:grpSpPr>
        <p:grpSp>
          <p:nvGrpSpPr>
            <p:cNvPr id="37" name="Group 36"/>
            <p:cNvGrpSpPr/>
            <p:nvPr/>
          </p:nvGrpSpPr>
          <p:grpSpPr>
            <a:xfrm>
              <a:off x="538165" y="451338"/>
              <a:ext cx="1524000" cy="1143000"/>
              <a:chOff x="4258751" y="4419600"/>
              <a:chExt cx="1676400" cy="1295400"/>
            </a:xfrm>
            <a:solidFill>
              <a:schemeClr val="bg1"/>
            </a:solidFill>
          </p:grpSpPr>
          <p:sp>
            <p:nvSpPr>
              <p:cNvPr id="38" name="Rectangle 37"/>
              <p:cNvSpPr/>
              <p:nvPr/>
            </p:nvSpPr>
            <p:spPr>
              <a:xfrm>
                <a:off x="4258751" y="4419600"/>
                <a:ext cx="1676400" cy="1295400"/>
              </a:xfrm>
              <a:prstGeom prst="rect">
                <a:avLst/>
              </a:prstGeom>
              <a:grp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953000" y="4876800"/>
                <a:ext cx="304800" cy="418576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+</a:t>
                </a:r>
                <a:endParaRPr lang="en-US" dirty="0"/>
              </a:p>
            </p:txBody>
          </p:sp>
        </p:grpSp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441136" y="990600"/>
              <a:ext cx="1524000" cy="1143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7" name="Picture 9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74511" y="1254369"/>
              <a:ext cx="851176" cy="6105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4" name="Group 33"/>
            <p:cNvGrpSpPr/>
            <p:nvPr/>
          </p:nvGrpSpPr>
          <p:grpSpPr>
            <a:xfrm>
              <a:off x="2279336" y="1676400"/>
              <a:ext cx="1524000" cy="1143000"/>
              <a:chOff x="1292060" y="3352800"/>
              <a:chExt cx="1676400" cy="1295400"/>
            </a:xfrm>
            <a:solidFill>
              <a:schemeClr val="bg1"/>
            </a:solidFill>
          </p:grpSpPr>
          <p:sp>
            <p:nvSpPr>
              <p:cNvPr id="35" name="Rectangle 34"/>
              <p:cNvSpPr/>
              <p:nvPr/>
            </p:nvSpPr>
            <p:spPr>
              <a:xfrm>
                <a:off x="1292060" y="3352800"/>
                <a:ext cx="1676400" cy="1295400"/>
              </a:xfrm>
              <a:prstGeom prst="rect">
                <a:avLst/>
              </a:prstGeom>
              <a:grp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962620" y="3810000"/>
                <a:ext cx="304800" cy="380999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*</a:t>
                </a:r>
                <a:endParaRPr lang="en-US" dirty="0"/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3193736" y="2209800"/>
              <a:ext cx="1524000" cy="1143000"/>
              <a:chOff x="4258751" y="4419600"/>
              <a:chExt cx="1676400" cy="1295400"/>
            </a:xfrm>
            <a:solidFill>
              <a:schemeClr val="bg1"/>
            </a:solidFill>
          </p:grpSpPr>
          <p:sp>
            <p:nvSpPr>
              <p:cNvPr id="41" name="Rectangle 40"/>
              <p:cNvSpPr/>
              <p:nvPr/>
            </p:nvSpPr>
            <p:spPr>
              <a:xfrm>
                <a:off x="4258751" y="4419600"/>
                <a:ext cx="1676400" cy="1295400"/>
              </a:xfrm>
              <a:prstGeom prst="rect">
                <a:avLst/>
              </a:prstGeom>
              <a:grp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953000" y="4876800"/>
                <a:ext cx="304800" cy="381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+</a:t>
                </a:r>
                <a:endParaRPr lang="en-US" dirty="0"/>
              </a:p>
            </p:txBody>
          </p:sp>
        </p:grpSp>
        <p:pic>
          <p:nvPicPr>
            <p:cNvPr id="9" name="Picture 8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101962" y="2737705"/>
              <a:ext cx="1524000" cy="114849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" name="Picture 7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435337" y="3001474"/>
              <a:ext cx="841887" cy="6154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" name="TextBox 10"/>
            <p:cNvSpPr txBox="1"/>
            <p:nvPr/>
          </p:nvSpPr>
          <p:spPr>
            <a:xfrm>
              <a:off x="4537461" y="3197012"/>
              <a:ext cx="762000" cy="244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141662"/>
                  </a:solidFill>
                  <a:latin typeface="Times" pitchFamily="18" charset="0"/>
                </a:rPr>
                <a:t>XNTPU</a:t>
              </a:r>
              <a:endParaRPr lang="en-US" sz="1200" dirty="0">
                <a:solidFill>
                  <a:srgbClr val="141662"/>
                </a:solidFill>
                <a:latin typeface="Times" pitchFamily="18" charset="0"/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5098736" y="3426904"/>
              <a:ext cx="1524000" cy="1143000"/>
              <a:chOff x="1292060" y="3352800"/>
              <a:chExt cx="1676400" cy="1295400"/>
            </a:xfrm>
            <a:solidFill>
              <a:schemeClr val="bg1"/>
            </a:solidFill>
          </p:grpSpPr>
          <p:sp>
            <p:nvSpPr>
              <p:cNvPr id="26" name="Rectangle 25"/>
              <p:cNvSpPr/>
              <p:nvPr/>
            </p:nvSpPr>
            <p:spPr>
              <a:xfrm>
                <a:off x="1292060" y="3352800"/>
                <a:ext cx="1676400" cy="1295400"/>
              </a:xfrm>
              <a:prstGeom prst="rect">
                <a:avLst/>
              </a:prstGeom>
              <a:grp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057400" y="3810000"/>
                <a:ext cx="304800" cy="381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*</a:t>
                </a:r>
                <a:endParaRPr lang="en-US" dirty="0"/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6089336" y="3998404"/>
              <a:ext cx="1524000" cy="1143000"/>
              <a:chOff x="4258751" y="4419600"/>
              <a:chExt cx="1676400" cy="1295400"/>
            </a:xfrm>
            <a:solidFill>
              <a:schemeClr val="bg1"/>
            </a:solidFill>
          </p:grpSpPr>
          <p:sp>
            <p:nvSpPr>
              <p:cNvPr id="23" name="Rectangle 22"/>
              <p:cNvSpPr/>
              <p:nvPr/>
            </p:nvSpPr>
            <p:spPr>
              <a:xfrm>
                <a:off x="4258751" y="4419600"/>
                <a:ext cx="1676400" cy="1295400"/>
              </a:xfrm>
              <a:prstGeom prst="rect">
                <a:avLst/>
              </a:prstGeom>
              <a:grp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953000" y="4876800"/>
                <a:ext cx="304800" cy="381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+</a:t>
                </a:r>
                <a:endParaRPr lang="en-US" dirty="0"/>
              </a:p>
            </p:txBody>
          </p:sp>
        </p:grpSp>
        <p:pic>
          <p:nvPicPr>
            <p:cNvPr id="13" name="Picture 1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010400" y="4569904"/>
              <a:ext cx="1524000" cy="114901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4" name="Picture 14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343775" y="4833673"/>
              <a:ext cx="857250" cy="6154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TextBox 14"/>
            <p:cNvSpPr txBox="1"/>
            <p:nvPr/>
          </p:nvSpPr>
          <p:spPr>
            <a:xfrm>
              <a:off x="7459166" y="5053480"/>
              <a:ext cx="831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141662"/>
                  </a:solidFill>
                  <a:latin typeface="Times" pitchFamily="18" charset="0"/>
                </a:rPr>
                <a:t>PHONE</a:t>
              </a:r>
              <a:endParaRPr lang="en-US" sz="1200" dirty="0">
                <a:solidFill>
                  <a:srgbClr val="141662"/>
                </a:solidFill>
                <a:latin typeface="Times" pitchFamily="18" charset="0"/>
              </a:endParaRPr>
            </a:p>
          </p:txBody>
        </p:sp>
        <p:sp>
          <p:nvSpPr>
            <p:cNvPr id="43" name="Rectangle 1"/>
            <p:cNvSpPr>
              <a:spLocks noChangeArrowheads="1"/>
            </p:cNvSpPr>
            <p:nvPr/>
          </p:nvSpPr>
          <p:spPr bwMode="auto">
            <a:xfrm>
              <a:off x="726737" y="6089374"/>
              <a:ext cx="4665473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ko-KR" sz="1400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Supplementary Figure 1.  A schematic of the </a:t>
              </a:r>
              <a:r>
                <a:rPr lang="en-US" altLang="ko-KR" sz="1400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study conditions</a:t>
              </a:r>
              <a:endParaRPr lang="en-US" altLang="ko-KR" sz="1400" dirty="0" smtClean="0">
                <a:solidFill>
                  <a:prstClr val="black"/>
                </a:solidFill>
                <a:latin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062165" y="682823"/>
              <a:ext cx="11315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-distractor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712829" y="2429928"/>
              <a:ext cx="13587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tter-distractor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613336" y="4247927"/>
              <a:ext cx="13587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ord-distractor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26737" y="1594338"/>
            <a:ext cx="685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m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446391" y="2133600"/>
            <a:ext cx="835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0m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279336" y="2819400"/>
            <a:ext cx="835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0m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2221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3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exas at Arling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kpark</dc:creator>
  <cp:lastModifiedBy>Park, Heekyeong</cp:lastModifiedBy>
  <cp:revision>10</cp:revision>
  <dcterms:created xsi:type="dcterms:W3CDTF">2013-03-21T15:00:20Z</dcterms:created>
  <dcterms:modified xsi:type="dcterms:W3CDTF">2014-09-09T22:13:41Z</dcterms:modified>
</cp:coreProperties>
</file>